
<file path=[Content_Types].xml><?xml version="1.0" encoding="utf-8"?>
<Types xmlns="http://schemas.openxmlformats.org/package/2006/content-types"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1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1F14F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65" autoAdjust="0"/>
    <p:restoredTop sz="94608" autoAdjust="0"/>
  </p:normalViewPr>
  <p:slideViewPr>
    <p:cSldViewPr>
      <p:cViewPr>
        <p:scale>
          <a:sx n="70" d="100"/>
          <a:sy n="70" d="100"/>
        </p:scale>
        <p:origin x="-1212" y="-81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7634FF9-C2AB-4E97-9A7E-19E00212F2FA}" type="datetimeFigureOut">
              <a:rPr lang="en-US" smtClean="0"/>
              <a:pPr/>
              <a:t>4/23/201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BFA26E0-B82A-49EE-AE77-9A2C181AB28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364184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2526A-9441-4D23-8CCA-C4D41C3B8B6B}" type="datetimeFigureOut">
              <a:rPr lang="en-US" smtClean="0"/>
              <a:pPr/>
              <a:t>4/2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55718C-96A2-4B58-B0DB-18DE1C7DB13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2526A-9441-4D23-8CCA-C4D41C3B8B6B}" type="datetimeFigureOut">
              <a:rPr lang="en-US" smtClean="0"/>
              <a:pPr/>
              <a:t>4/2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55718C-96A2-4B58-B0DB-18DE1C7DB13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2526A-9441-4D23-8CCA-C4D41C3B8B6B}" type="datetimeFigureOut">
              <a:rPr lang="en-US" smtClean="0"/>
              <a:pPr/>
              <a:t>4/2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55718C-96A2-4B58-B0DB-18DE1C7DB13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2526A-9441-4D23-8CCA-C4D41C3B8B6B}" type="datetimeFigureOut">
              <a:rPr lang="en-US" smtClean="0"/>
              <a:pPr/>
              <a:t>4/2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55718C-96A2-4B58-B0DB-18DE1C7DB13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2526A-9441-4D23-8CCA-C4D41C3B8B6B}" type="datetimeFigureOut">
              <a:rPr lang="en-US" smtClean="0"/>
              <a:pPr/>
              <a:t>4/2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55718C-96A2-4B58-B0DB-18DE1C7DB13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2526A-9441-4D23-8CCA-C4D41C3B8B6B}" type="datetimeFigureOut">
              <a:rPr lang="en-US" smtClean="0"/>
              <a:pPr/>
              <a:t>4/23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55718C-96A2-4B58-B0DB-18DE1C7DB13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2526A-9441-4D23-8CCA-C4D41C3B8B6B}" type="datetimeFigureOut">
              <a:rPr lang="en-US" smtClean="0"/>
              <a:pPr/>
              <a:t>4/23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55718C-96A2-4B58-B0DB-18DE1C7DB13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2526A-9441-4D23-8CCA-C4D41C3B8B6B}" type="datetimeFigureOut">
              <a:rPr lang="en-US" smtClean="0"/>
              <a:pPr/>
              <a:t>4/23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55718C-96A2-4B58-B0DB-18DE1C7DB13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2526A-9441-4D23-8CCA-C4D41C3B8B6B}" type="datetimeFigureOut">
              <a:rPr lang="en-US" smtClean="0"/>
              <a:pPr/>
              <a:t>4/23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55718C-96A2-4B58-B0DB-18DE1C7DB13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2526A-9441-4D23-8CCA-C4D41C3B8B6B}" type="datetimeFigureOut">
              <a:rPr lang="en-US" smtClean="0"/>
              <a:pPr/>
              <a:t>4/23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55718C-96A2-4B58-B0DB-18DE1C7DB13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2526A-9441-4D23-8CCA-C4D41C3B8B6B}" type="datetimeFigureOut">
              <a:rPr lang="en-US" smtClean="0"/>
              <a:pPr/>
              <a:t>4/23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55718C-96A2-4B58-B0DB-18DE1C7DB13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72526A-9441-4D23-8CCA-C4D41C3B8B6B}" type="datetimeFigureOut">
              <a:rPr lang="en-US" smtClean="0"/>
              <a:pPr/>
              <a:t>4/2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55718C-96A2-4B58-B0DB-18DE1C7DB138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228600" y="1336675"/>
            <a:ext cx="8746533" cy="544978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3" name="TextBox 2"/>
          <p:cNvSpPr txBox="1"/>
          <p:nvPr/>
        </p:nvSpPr>
        <p:spPr>
          <a:xfrm>
            <a:off x="0" y="0"/>
            <a:ext cx="91440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600" dirty="0" smtClean="0"/>
              <a:t>S5: Modeling of  the CRF02_A/G integrase Model 4 (A) and the (B) alignment of the model with the 'best' two possible templates. </a:t>
            </a:r>
            <a:endParaRPr lang="en-US" sz="1600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Custom 1">
      <a:majorFont>
        <a:latin typeface="Arial Narrow"/>
        <a:ea typeface=""/>
        <a:cs typeface=""/>
      </a:majorFont>
      <a:minorFont>
        <a:latin typeface="Arial Narrow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731</TotalTime>
  <Words>29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IllustriousII</dc:creator>
  <cp:lastModifiedBy>Estrella Moyal2</cp:lastModifiedBy>
  <cp:revision>408</cp:revision>
  <dcterms:created xsi:type="dcterms:W3CDTF">2015-02-06T16:45:11Z</dcterms:created>
  <dcterms:modified xsi:type="dcterms:W3CDTF">2015-04-23T14:33:07Z</dcterms:modified>
</cp:coreProperties>
</file>